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/03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961718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/03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749175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/03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82447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/03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176087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/03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41786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/03/202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358306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/03/2026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800096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/03/2026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299262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/03/2026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049406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/03/202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726933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/03/202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76647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38ECEC-DE40-4701-AE29-5E36A6639E95}" type="datetimeFigureOut">
              <a:rPr lang="en-AU" smtClean="0"/>
              <a:t>2/03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257765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0" y="-48399"/>
            <a:ext cx="1659878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</a:t>
            </a:r>
            <a:r>
              <a:rPr kumimoji="0" lang="en-US" altLang="en-US" sz="1200" b="0" i="1" u="none" strike="noStrike" cap="none" normalizeH="0" baseline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</a:t>
            </a:r>
            <a:r>
              <a:rPr kumimoji="0" lang="en-US" altLang="en-US" sz="1200" b="0" i="1" u="none" strike="noStrike" cap="none" normalizeH="0" baseline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</a:t>
            </a:r>
            <a:endParaRPr kumimoji="0" lang="en-AU" alt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AU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10241" name="Picture 3" descr="hitman_heatmap_HCQ dose groups_page-000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57200"/>
            <a:ext cx="3619500" cy="46101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3"/>
          <p:cNvSpPr>
            <a:spLocks noChangeArrowheads="1"/>
          </p:cNvSpPr>
          <p:nvPr/>
        </p:nvSpPr>
        <p:spPr bwMode="auto">
          <a:xfrm>
            <a:off x="0" y="5489773"/>
            <a:ext cx="10896600" cy="6155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ffect of </a:t>
            </a:r>
            <a:r>
              <a:rPr kumimoji="0" lang="en-US" altLang="en-US" sz="1200" b="0" i="1" u="none" strike="noStrike" cap="none" normalizeH="0" baseline="0" dirty="0" err="1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ydroxychloroquine</a:t>
            </a:r>
            <a:r>
              <a:rPr kumimoji="0" lang="en-US" altLang="en-US" sz="1200" b="0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HCQ) Dose on Treatment-Altered Lipids.</a:t>
            </a:r>
            <a:endParaRPr kumimoji="0" lang="en-AU" alt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eatmap</a:t>
            </a:r>
            <a:r>
              <a:rPr kumimoji="0" lang="en-AU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howing the fold change for lipids that showed a significantly different magnitude of change between the different HCQ dose groups (low: 200mg BD; mid: 400mg BD; high: 600mg BD). The asterisks (*) indicate a significant difference in fold change compared to the low-dose group.</a:t>
            </a:r>
            <a:endParaRPr kumimoji="0" lang="en-AU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17657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67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SVH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ak Talmor - SVHNS</dc:creator>
  <cp:lastModifiedBy>Barak Talmor - SVHNS</cp:lastModifiedBy>
  <cp:revision>11</cp:revision>
  <dcterms:created xsi:type="dcterms:W3CDTF">2026-02-22T23:33:58Z</dcterms:created>
  <dcterms:modified xsi:type="dcterms:W3CDTF">2026-03-01T23:27:01Z</dcterms:modified>
</cp:coreProperties>
</file>